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52560" y="685440"/>
            <a:ext cx="495288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  <a:defRPr b="0" lang="en-I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FF6B3630-5049-4192-BA4B-A9467B52C68F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952560" y="685800"/>
            <a:ext cx="495288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1220760"/>
                <a:tab algn="l" pos="2441520"/>
                <a:tab algn="l" pos="3662280"/>
                <a:tab algn="l" pos="4883040"/>
                <a:tab algn="l" pos="6103800"/>
                <a:tab algn="l" pos="7324560"/>
                <a:tab algn="l" pos="8545680"/>
                <a:tab algn="l" pos="9766440"/>
              </a:tabLst>
            </a:pPr>
            <a:fld id="{B3799BE4-F6A7-477A-9E25-2205DCE90BD9}" type="slidenum">
              <a:rPr b="0" lang="en-I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CE7FC-2392-4A4C-85E4-45F56145E7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12E824-1778-46B6-82DD-ACE5DC302F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FA339-7688-49F0-9371-6732171C9B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201AB-85CF-4081-9033-D6744CE15A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4A70B-0B0F-4796-9DB7-633808D2D2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A6CCF-FAE8-493B-BD93-18FE70C46F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05696-BB40-48EA-8C18-427E09659C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D945C-D12E-4FA8-8B96-F21252D2C9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3FB3D-E0C8-4943-AE0D-D0E7B7F76C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C3090B-C54A-4E48-A9D1-1EA28FB57E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411C8-4FD4-46AF-B77A-C7DA5092C1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BFF5A-FD0F-400F-A555-C2B93E834F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460A0693-AA1D-4056-8ED0-AB33CA2AA6D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91"/>
          <p:cNvSpPr/>
          <p:nvPr/>
        </p:nvSpPr>
        <p:spPr>
          <a:xfrm>
            <a:off x="1143000" y="5892840"/>
            <a:ext cx="76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I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5"/>
          <p:cNvGrpSpPr/>
          <p:nvPr/>
        </p:nvGrpSpPr>
        <p:grpSpPr>
          <a:xfrm>
            <a:off x="2362320" y="151920"/>
            <a:ext cx="5004360" cy="5334480"/>
            <a:chOff x="2362320" y="151920"/>
            <a:chExt cx="5004360" cy="5334480"/>
          </a:xfrm>
        </p:grpSpPr>
        <p:pic>
          <p:nvPicPr>
            <p:cNvPr id="50" name="Picture 3" descr=""/>
            <p:cNvPicPr/>
            <p:nvPr/>
          </p:nvPicPr>
          <p:blipFill>
            <a:blip r:embed="rId1"/>
            <a:stretch/>
          </p:blipFill>
          <p:spPr>
            <a:xfrm>
              <a:off x="3276360" y="2611800"/>
              <a:ext cx="3657240" cy="2874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3"/>
            <p:cNvSpPr/>
            <p:nvPr/>
          </p:nvSpPr>
          <p:spPr>
            <a:xfrm rot="16981200">
              <a:off x="2836800" y="1629360"/>
              <a:ext cx="177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kb plus ladd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3"/>
            <p:cNvSpPr/>
            <p:nvPr/>
          </p:nvSpPr>
          <p:spPr>
            <a:xfrm rot="16981200">
              <a:off x="3059640" y="1520280"/>
              <a:ext cx="200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 (Immature fruit cD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3"/>
            <p:cNvSpPr/>
            <p:nvPr/>
          </p:nvSpPr>
          <p:spPr>
            <a:xfrm rot="16981200">
              <a:off x="3431160" y="1520280"/>
              <a:ext cx="200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 (Young leaves cD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3"/>
            <p:cNvSpPr/>
            <p:nvPr/>
          </p:nvSpPr>
          <p:spPr>
            <a:xfrm rot="16981200">
              <a:off x="3780000" y="1424160"/>
              <a:ext cx="22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LF4a (Immature fruit cD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3"/>
            <p:cNvSpPr/>
            <p:nvPr/>
          </p:nvSpPr>
          <p:spPr>
            <a:xfrm rot="16981200">
              <a:off x="4209840" y="1408680"/>
              <a:ext cx="223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LF4a (Young leaves cD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3"/>
            <p:cNvSpPr/>
            <p:nvPr/>
          </p:nvSpPr>
          <p:spPr>
            <a:xfrm rot="16981200">
              <a:off x="4617720" y="1368000"/>
              <a:ext cx="231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 (Immature fruit total R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3"/>
            <p:cNvSpPr/>
            <p:nvPr/>
          </p:nvSpPr>
          <p:spPr>
            <a:xfrm rot="16981200">
              <a:off x="5019840" y="1364760"/>
              <a:ext cx="232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 (Young leaves total R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3"/>
            <p:cNvSpPr/>
            <p:nvPr/>
          </p:nvSpPr>
          <p:spPr>
            <a:xfrm rot="16981200">
              <a:off x="5326560" y="1271160"/>
              <a:ext cx="25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LF4a (Immature fruit total R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"/>
            <p:cNvSpPr/>
            <p:nvPr/>
          </p:nvSpPr>
          <p:spPr>
            <a:xfrm rot="16981200">
              <a:off x="5737320" y="1308240"/>
              <a:ext cx="2440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LF4a (Young leaves total RN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66"/>
            <p:cNvSpPr/>
            <p:nvPr/>
          </p:nvSpPr>
          <p:spPr>
            <a:xfrm>
              <a:off x="3252600" y="2664000"/>
              <a:ext cx="380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IN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  </a:t>
              </a:r>
              <a:r>
                <a:rPr b="0" lang="en-IN" sz="12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1        2        3          4         5          6         7        8        9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61"/>
            <p:cNvSpPr/>
            <p:nvPr/>
          </p:nvSpPr>
          <p:spPr>
            <a:xfrm>
              <a:off x="2362320" y="3510720"/>
              <a:ext cx="95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I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50 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2" name="Straight Arrow Connector 16"/>
            <p:cNvCxnSpPr/>
            <p:nvPr/>
          </p:nvCxnSpPr>
          <p:spPr>
            <a:xfrm flipH="1" flipV="1">
              <a:off x="2999520" y="3655800"/>
              <a:ext cx="27684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3" name="Straight Arrow Connector 17"/>
            <p:cNvCxnSpPr/>
            <p:nvPr/>
          </p:nvCxnSpPr>
          <p:spPr>
            <a:xfrm flipH="1" flipV="1">
              <a:off x="2999520" y="4038480"/>
              <a:ext cx="27684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4" name="TextBox 63"/>
            <p:cNvSpPr/>
            <p:nvPr/>
          </p:nvSpPr>
          <p:spPr>
            <a:xfrm>
              <a:off x="2438280" y="3886200"/>
              <a:ext cx="92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I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50 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5" name="Straight Arrow Connector 19"/>
            <p:cNvCxnSpPr/>
            <p:nvPr/>
          </p:nvCxnSpPr>
          <p:spPr>
            <a:xfrm flipH="1" flipV="1">
              <a:off x="2999520" y="4342680"/>
              <a:ext cx="2768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6" name="TextBox 65"/>
            <p:cNvSpPr/>
            <p:nvPr/>
          </p:nvSpPr>
          <p:spPr>
            <a:xfrm>
              <a:off x="2423160" y="4191120"/>
              <a:ext cx="92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I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 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7" name="Straight Arrow Connector 21"/>
            <p:cNvCxnSpPr/>
            <p:nvPr/>
          </p:nvCxnSpPr>
          <p:spPr>
            <a:xfrm flipH="1" flipV="1">
              <a:off x="2999520" y="4571280"/>
              <a:ext cx="2768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8" name="TextBox 65"/>
            <p:cNvSpPr/>
            <p:nvPr/>
          </p:nvSpPr>
          <p:spPr>
            <a:xfrm>
              <a:off x="2423160" y="4419720"/>
              <a:ext cx="92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I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0 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Oval 24"/>
            <p:cNvSpPr/>
            <p:nvPr/>
          </p:nvSpPr>
          <p:spPr>
            <a:xfrm>
              <a:off x="3608280" y="4370400"/>
              <a:ext cx="1752480" cy="533160"/>
            </a:xfrm>
            <a:prstGeom prst="ellipse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Raja R</dc:creator>
  <dc:description/>
  <dc:language>en-US</dc:language>
  <cp:lastModifiedBy>Dr.Vikrant</cp:lastModifiedBy>
  <dcterms:modified xsi:type="dcterms:W3CDTF">2013-02-10T06:06:19Z</dcterms:modified>
  <cp:revision>213</cp:revision>
  <dc:subject/>
  <dc:title>Slide 1</dc:title>
</cp:coreProperties>
</file>